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  <p:sldId id="258" r:id="rId3"/>
    <p:sldId id="262" r:id="rId4"/>
    <p:sldId id="260" r:id="rId5"/>
    <p:sldId id="263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D9D9D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DF670634-7A3B-418C-B520-6A11601F87D3}" v="1" dt="2022-10-18T12:30:38.697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59" d="100"/>
          <a:sy n="59" d="100"/>
        </p:scale>
        <p:origin x="856" y="6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microsoft.com/office/2015/10/relationships/revisionInfo" Target="revisionInfo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27F0528-929D-4340-834B-643B720F4E2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0D3DAE1-E6CC-4CD8-97D1-EB49554E86F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6B6BAC3-6B0B-49AC-88E6-3C108489A2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480FF2-3118-4A6A-92D8-57AB8D07CE94}" type="datetimeFigureOut">
              <a:rPr lang="en-AU" smtClean="0"/>
              <a:t>31/12/2022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7898298-6B48-45C9-A956-67D24F6612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FD5BA33-8A93-4E6C-B5E9-2E9124DA36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BA1B9D-ACF7-43A0-A8E8-83BF54A5A00F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6878664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01CB351-081D-4124-B506-7CA684F800F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D3B1D64-EB7D-43F6-9B11-B5B6746CE35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AA94DF3-F418-466B-A1CA-2BA30BFD8F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480FF2-3118-4A6A-92D8-57AB8D07CE94}" type="datetimeFigureOut">
              <a:rPr lang="en-AU" smtClean="0"/>
              <a:t>31/12/2022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8645BFA-B78F-463C-AF90-B5AF6C046F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11B4F75-565F-4481-8A64-0008DF5548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BA1B9D-ACF7-43A0-A8E8-83BF54A5A00F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8438636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422E437-76BA-4E21-BBEA-F1537559636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8D0D593-23AD-4D28-AE3D-CC43F128AD9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A8809A8-A2B9-40A4-9E90-8F4B73EF53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480FF2-3118-4A6A-92D8-57AB8D07CE94}" type="datetimeFigureOut">
              <a:rPr lang="en-AU" smtClean="0"/>
              <a:t>31/12/2022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68B26EB-316E-4028-A3B4-2C83A7B12A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6576545-9533-4FE0-A052-50F24E3217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BA1B9D-ACF7-43A0-A8E8-83BF54A5A00F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7099920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EC3F4C0-FB5F-4081-9E35-F2B221EDFF7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3DCB96F-0719-4C80-B335-BF3874A4E24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F8DA432-39FB-4901-B976-2A87A18EF9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480FF2-3118-4A6A-92D8-57AB8D07CE94}" type="datetimeFigureOut">
              <a:rPr lang="en-AU" smtClean="0"/>
              <a:t>31/12/2022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C938B0F-06FF-47F5-8B1D-EDCB3F1EE3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46CD1D9-00C2-4AFB-B206-02C17AE0C8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BA1B9D-ACF7-43A0-A8E8-83BF54A5A00F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4424803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D0C80C-1B52-411B-95D8-515DFAE2352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78D4671-5803-4862-AADF-C48D648D96D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DE5B14A-9789-45B2-9530-CA01E0889E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480FF2-3118-4A6A-92D8-57AB8D07CE94}" type="datetimeFigureOut">
              <a:rPr lang="en-AU" smtClean="0"/>
              <a:t>31/12/2022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B76F9E0-FBE1-443D-A2F4-4E6CEEFAB8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A0D7BF2-3B07-4951-ABC6-FD7E1EA93F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BA1B9D-ACF7-43A0-A8E8-83BF54A5A00F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5895959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359A716-0E59-4C10-A08A-28BE4B0536F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76DE020-07AF-41E6-A48C-F3526AE400D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EE32B92-B862-45F9-80F4-6A61EBF4FB8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4008C14-37AC-4655-B94A-2E1C3A10BD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480FF2-3118-4A6A-92D8-57AB8D07CE94}" type="datetimeFigureOut">
              <a:rPr lang="en-AU" smtClean="0"/>
              <a:t>31/12/2022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1AB55FC-7EAC-4261-AEB4-B066B9E966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59F7BE8-4E23-4EAE-B751-080D64EE8D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BA1B9D-ACF7-43A0-A8E8-83BF54A5A00F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0384213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660B660-6300-4189-934C-ED7C2EFF941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2099FAA-39F4-457C-B93E-2AFEF88EC03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59A00EB-095C-4023-8900-85559F2C8FC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A8F3F9D-0760-4CB4-97D7-9ED072480D8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003515D-D8CB-4D54-AD34-261D51BBB38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4D2AC17-7FF9-4604-B9F3-1485DD3DDC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480FF2-3118-4A6A-92D8-57AB8D07CE94}" type="datetimeFigureOut">
              <a:rPr lang="en-AU" smtClean="0"/>
              <a:t>31/12/2022</a:t>
            </a:fld>
            <a:endParaRPr lang="en-AU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65DAE0D-D06F-4A64-9F76-9806C91917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6ACF4D8-B39B-4071-9A0D-F45DF7CD7C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BA1B9D-ACF7-43A0-A8E8-83BF54A5A00F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7870223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4DBFFA7-70FD-4DA6-9B07-621940A095B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2A68370-09A7-4C7D-9E6D-4DEE6A2749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480FF2-3118-4A6A-92D8-57AB8D07CE94}" type="datetimeFigureOut">
              <a:rPr lang="en-AU" smtClean="0"/>
              <a:t>31/12/2022</a:t>
            </a:fld>
            <a:endParaRPr lang="en-AU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14EF434-B0BB-4879-A30D-5954F217E6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AFAA869-A0E1-44D7-A02D-5B38D57667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BA1B9D-ACF7-43A0-A8E8-83BF54A5A00F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2160327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ED0D934-70C2-4B7C-B4CB-F536B86B43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480FF2-3118-4A6A-92D8-57AB8D07CE94}" type="datetimeFigureOut">
              <a:rPr lang="en-AU" smtClean="0"/>
              <a:t>31/12/2022</a:t>
            </a:fld>
            <a:endParaRPr lang="en-AU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A6A2A60-9E59-4C50-97AA-A53EA9141F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FDF52F0-2850-4F94-9D2D-BFE083FA56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BA1B9D-ACF7-43A0-A8E8-83BF54A5A00F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845574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8DF8961-75DA-425B-8EA4-C2E997F71E2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7E59273-7971-43E4-B1D6-EDB2EC82396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0F6B541-A6FE-4410-9031-F0AE8900DFB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83C0893-B077-46AF-8318-5AA186ECEF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480FF2-3118-4A6A-92D8-57AB8D07CE94}" type="datetimeFigureOut">
              <a:rPr lang="en-AU" smtClean="0"/>
              <a:t>31/12/2022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AEC0DD6-B197-46CD-968C-47FDAA5080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8E83653-E958-48A4-A5CB-EF0423440F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BA1B9D-ACF7-43A0-A8E8-83BF54A5A00F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7742451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5D96C38-7038-4317-AAD0-00CE7C4D50B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1BF1E44-949B-44E2-8563-A319FADCDF6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87A9236-9881-47BD-B40B-F8F113EEAF9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D25E18F-729E-4923-B963-3878451359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480FF2-3118-4A6A-92D8-57AB8D07CE94}" type="datetimeFigureOut">
              <a:rPr lang="en-AU" smtClean="0"/>
              <a:t>31/12/2022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5405186-051A-4EEE-B4CA-02586A258C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F66D561-1A77-4E7A-8473-DF26CA1416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BA1B9D-ACF7-43A0-A8E8-83BF54A5A00F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627057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69AB576-38CD-4B91-A0C3-89EB0C91E73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5DCAA8E-4CD2-4AE1-A85A-4066055A5DC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8505EDF-160A-4680-99F2-B15DE85D909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480FF2-3118-4A6A-92D8-57AB8D07CE94}" type="datetimeFigureOut">
              <a:rPr lang="en-AU" smtClean="0"/>
              <a:t>31/12/2022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8D4FCFA-7462-49D0-A9FE-DC2B710207D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FEAD33C-FC2C-4988-B58E-283D699C5E2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BA1B9D-ACF7-43A0-A8E8-83BF54A5A00F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1397888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.png"/><Relationship Id="rId5" Type="http://schemas.openxmlformats.org/officeDocument/2006/relationships/image" Target="../media/image6.png"/><Relationship Id="rId4" Type="http://schemas.openxmlformats.org/officeDocument/2006/relationships/image" Target="../media/image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1CB218CB-B1D0-B8B2-7027-070A531E086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80566954"/>
              </p:ext>
            </p:extLst>
          </p:nvPr>
        </p:nvGraphicFramePr>
        <p:xfrm>
          <a:off x="86263" y="318971"/>
          <a:ext cx="11878574" cy="6539029"/>
        </p:xfrm>
        <a:graphic>
          <a:graphicData uri="http://schemas.openxmlformats.org/drawingml/2006/table">
            <a:tbl>
              <a:tblPr firstRow="1" firstCol="1" bandRow="1"/>
              <a:tblGrid>
                <a:gridCol w="845952">
                  <a:extLst>
                    <a:ext uri="{9D8B030D-6E8A-4147-A177-3AD203B41FA5}">
                      <a16:colId xmlns:a16="http://schemas.microsoft.com/office/drawing/2014/main" val="3514212716"/>
                    </a:ext>
                  </a:extLst>
                </a:gridCol>
                <a:gridCol w="1286551">
                  <a:extLst>
                    <a:ext uri="{9D8B030D-6E8A-4147-A177-3AD203B41FA5}">
                      <a16:colId xmlns:a16="http://schemas.microsoft.com/office/drawing/2014/main" val="3000039354"/>
                    </a:ext>
                  </a:extLst>
                </a:gridCol>
                <a:gridCol w="1286551">
                  <a:extLst>
                    <a:ext uri="{9D8B030D-6E8A-4147-A177-3AD203B41FA5}">
                      <a16:colId xmlns:a16="http://schemas.microsoft.com/office/drawing/2014/main" val="3159559116"/>
                    </a:ext>
                  </a:extLst>
                </a:gridCol>
                <a:gridCol w="845952">
                  <a:extLst>
                    <a:ext uri="{9D8B030D-6E8A-4147-A177-3AD203B41FA5}">
                      <a16:colId xmlns:a16="http://schemas.microsoft.com/office/drawing/2014/main" val="2639325145"/>
                    </a:ext>
                  </a:extLst>
                </a:gridCol>
                <a:gridCol w="845952">
                  <a:extLst>
                    <a:ext uri="{9D8B030D-6E8A-4147-A177-3AD203B41FA5}">
                      <a16:colId xmlns:a16="http://schemas.microsoft.com/office/drawing/2014/main" val="1638390539"/>
                    </a:ext>
                  </a:extLst>
                </a:gridCol>
                <a:gridCol w="845952">
                  <a:extLst>
                    <a:ext uri="{9D8B030D-6E8A-4147-A177-3AD203B41FA5}">
                      <a16:colId xmlns:a16="http://schemas.microsoft.com/office/drawing/2014/main" val="737152098"/>
                    </a:ext>
                  </a:extLst>
                </a:gridCol>
                <a:gridCol w="845952">
                  <a:extLst>
                    <a:ext uri="{9D8B030D-6E8A-4147-A177-3AD203B41FA5}">
                      <a16:colId xmlns:a16="http://schemas.microsoft.com/office/drawing/2014/main" val="1466638929"/>
                    </a:ext>
                  </a:extLst>
                </a:gridCol>
                <a:gridCol w="845952">
                  <a:extLst>
                    <a:ext uri="{9D8B030D-6E8A-4147-A177-3AD203B41FA5}">
                      <a16:colId xmlns:a16="http://schemas.microsoft.com/office/drawing/2014/main" val="4152430038"/>
                    </a:ext>
                  </a:extLst>
                </a:gridCol>
                <a:gridCol w="845952">
                  <a:extLst>
                    <a:ext uri="{9D8B030D-6E8A-4147-A177-3AD203B41FA5}">
                      <a16:colId xmlns:a16="http://schemas.microsoft.com/office/drawing/2014/main" val="1257316604"/>
                    </a:ext>
                  </a:extLst>
                </a:gridCol>
                <a:gridCol w="845952">
                  <a:extLst>
                    <a:ext uri="{9D8B030D-6E8A-4147-A177-3AD203B41FA5}">
                      <a16:colId xmlns:a16="http://schemas.microsoft.com/office/drawing/2014/main" val="1263431924"/>
                    </a:ext>
                  </a:extLst>
                </a:gridCol>
                <a:gridCol w="845952">
                  <a:extLst>
                    <a:ext uri="{9D8B030D-6E8A-4147-A177-3AD203B41FA5}">
                      <a16:colId xmlns:a16="http://schemas.microsoft.com/office/drawing/2014/main" val="1210290796"/>
                    </a:ext>
                  </a:extLst>
                </a:gridCol>
                <a:gridCol w="845952">
                  <a:extLst>
                    <a:ext uri="{9D8B030D-6E8A-4147-A177-3AD203B41FA5}">
                      <a16:colId xmlns:a16="http://schemas.microsoft.com/office/drawing/2014/main" val="2812657353"/>
                    </a:ext>
                  </a:extLst>
                </a:gridCol>
                <a:gridCol w="845952">
                  <a:extLst>
                    <a:ext uri="{9D8B030D-6E8A-4147-A177-3AD203B41FA5}">
                      <a16:colId xmlns:a16="http://schemas.microsoft.com/office/drawing/2014/main" val="2858340209"/>
                    </a:ext>
                  </a:extLst>
                </a:gridCol>
              </a:tblGrid>
              <a:tr h="123227"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tient ID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utation</a:t>
                      </a:r>
                    </a:p>
                  </a:txBody>
                  <a:tcPr marL="3425" marR="3425" marT="34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osition</a:t>
                      </a:r>
                    </a:p>
                  </a:txBody>
                  <a:tcPr marL="3425" marR="3425" marT="3425" marB="0" anchor="ctr">
                    <a:lnL>
                      <a:noFill/>
                    </a:lnL>
                    <a:lnR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AU" sz="8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ncomine</a:t>
                      </a:r>
                      <a:endParaRPr lang="en-AU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425" marR="3425" marT="3425" marB="0" anchor="ctr">
                    <a:lnL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3425" marR="3425" marT="3425" marB="0" anchor="ctr">
                    <a:lnL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5">
                  <a:txBody>
                    <a:bodyPr/>
                    <a:lstStyle/>
                    <a:p>
                      <a:pPr algn="ctr" fontAlgn="ctr"/>
                      <a:r>
                        <a:rPr lang="en-AU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cel</a:t>
                      </a:r>
                    </a:p>
                  </a:txBody>
                  <a:tcPr marL="3425" marR="3425" marT="3425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259713527"/>
                  </a:ext>
                </a:extLst>
              </a:tr>
              <a:tr h="123227">
                <a:tc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AU" sz="8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fDNA</a:t>
                      </a:r>
                    </a:p>
                  </a:txBody>
                  <a:tcPr marL="3425" marR="3425" marT="3425" marB="0" anchor="ctr">
                    <a:lnL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AU" sz="8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fDNA</a:t>
                      </a:r>
                    </a:p>
                  </a:txBody>
                  <a:tcPr marL="3425" marR="3425" marT="3425" marB="0" anchor="ctr">
                    <a:lnL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AU" sz="8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umor</a:t>
                      </a:r>
                    </a:p>
                  </a:txBody>
                  <a:tcPr marL="3425" marR="3425" marT="3425" marB="0" anchor="ctr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AU" sz="8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ealthy Tissue</a:t>
                      </a:r>
                    </a:p>
                  </a:txBody>
                  <a:tcPr marL="3425" marR="3425" marT="3425" marB="0" anchor="ctr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257443462"/>
                  </a:ext>
                </a:extLst>
              </a:tr>
              <a:tr h="123227">
                <a:tc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AU" sz="8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otal Reads</a:t>
                      </a:r>
                    </a:p>
                  </a:txBody>
                  <a:tcPr marL="3425" marR="3425" marT="3425" marB="0" anchor="ctr">
                    <a:lnL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AU" sz="8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otal Mol Coverage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AU" sz="8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llele Mol Coverage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llele 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otal </a:t>
                      </a:r>
                    </a:p>
                  </a:txBody>
                  <a:tcPr marL="3425" marR="3425" marT="3425" marB="0" anchor="ctr">
                    <a:lnL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llele 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otal </a:t>
                      </a:r>
                    </a:p>
                  </a:txBody>
                  <a:tcPr marL="3425" marR="3425" marT="3425" marB="0" anchor="ctr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llele 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AU" sz="8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otal Reads</a:t>
                      </a:r>
                    </a:p>
                  </a:txBody>
                  <a:tcPr marL="3425" marR="3425" marT="3425" marB="0" anchor="ctr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llele 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13557577"/>
                  </a:ext>
                </a:extLst>
              </a:tr>
              <a:tr h="123227">
                <a:tc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requency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ads</a:t>
                      </a:r>
                    </a:p>
                  </a:txBody>
                  <a:tcPr marL="3425" marR="3425" marT="3425" marB="0" anchor="ctr">
                    <a:lnL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requency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ads</a:t>
                      </a:r>
                    </a:p>
                  </a:txBody>
                  <a:tcPr marL="3425" marR="3425" marT="3425" marB="0" anchor="ctr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requency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requency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30222567"/>
                  </a:ext>
                </a:extLst>
              </a:tr>
              <a:tr h="156281"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C1</a:t>
                      </a:r>
                    </a:p>
                  </a:txBody>
                  <a:tcPr marL="3425" marR="3425" marT="3425" marB="0" anchor="ctr">
                    <a:lnL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.R282G</a:t>
                      </a:r>
                    </a:p>
                  </a:txBody>
                  <a:tcPr marL="3425" marR="3425" marT="34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577094 (G/C)</a:t>
                      </a:r>
                    </a:p>
                  </a:txBody>
                  <a:tcPr marL="3425" marR="3425" marT="3425" marB="0" anchor="ctr">
                    <a:lnL>
                      <a:noFill/>
                    </a:lnL>
                    <a:lnR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CC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9,278</a:t>
                      </a:r>
                    </a:p>
                  </a:txBody>
                  <a:tcPr marL="3425" marR="3425" marT="3425" marB="0" anchor="ctr">
                    <a:lnL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C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11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C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C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4%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C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2077</a:t>
                      </a:r>
                    </a:p>
                  </a:txBody>
                  <a:tcPr marL="3425" marR="3425" marT="3425" marB="0" anchor="ctr">
                    <a:lnL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C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0%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C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8081</a:t>
                      </a:r>
                    </a:p>
                  </a:txBody>
                  <a:tcPr marL="3425" marR="3425" marT="3425" marB="0" anchor="ctr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C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5%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C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309</a:t>
                      </a:r>
                    </a:p>
                  </a:txBody>
                  <a:tcPr marL="3425" marR="3425" marT="3425" marB="0" anchor="ctr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%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44685314"/>
                  </a:ext>
                </a:extLst>
              </a:tr>
              <a:tr h="156281">
                <a:tc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.R249S</a:t>
                      </a:r>
                    </a:p>
                  </a:txBody>
                  <a:tcPr marL="3425" marR="3425" marT="34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577534 (C/A)</a:t>
                      </a:r>
                    </a:p>
                  </a:txBody>
                  <a:tcPr marL="3425" marR="3425" marT="3425" marB="0" anchor="ctr">
                    <a:lnL>
                      <a:noFill/>
                    </a:lnL>
                    <a:lnR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3,760</a:t>
                      </a:r>
                    </a:p>
                  </a:txBody>
                  <a:tcPr marL="3425" marR="3425" marT="3425" marB="0" anchor="ctr">
                    <a:lnL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,301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4%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3513</a:t>
                      </a:r>
                    </a:p>
                  </a:txBody>
                  <a:tcPr marL="3425" marR="3425" marT="3425" marB="0" anchor="ctr">
                    <a:lnL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%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656</a:t>
                      </a:r>
                    </a:p>
                  </a:txBody>
                  <a:tcPr marL="3425" marR="3425" marT="3425" marB="0" anchor="ctr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%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374</a:t>
                      </a:r>
                    </a:p>
                  </a:txBody>
                  <a:tcPr marL="3425" marR="3425" marT="3425" marB="0" anchor="ctr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%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9011642"/>
                  </a:ext>
                </a:extLst>
              </a:tr>
              <a:tr h="156281">
                <a:tc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AU" sz="8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.Y233C</a:t>
                      </a:r>
                    </a:p>
                  </a:txBody>
                  <a:tcPr marL="3425" marR="3425" marT="34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577583 (T/G)</a:t>
                      </a:r>
                    </a:p>
                  </a:txBody>
                  <a:tcPr marL="3425" marR="3425" marT="3425" marB="0" anchor="ctr">
                    <a:lnL>
                      <a:noFill/>
                    </a:lnL>
                    <a:lnR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3,760</a:t>
                      </a:r>
                    </a:p>
                  </a:txBody>
                  <a:tcPr marL="3425" marR="3425" marT="3425" marB="0" anchor="ctr">
                    <a:lnL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8E8E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,301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%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435</a:t>
                      </a:r>
                    </a:p>
                  </a:txBody>
                  <a:tcPr marL="3425" marR="3425" marT="3425" marB="0" anchor="ctr">
                    <a:lnL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%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435</a:t>
                      </a:r>
                    </a:p>
                  </a:txBody>
                  <a:tcPr marL="3425" marR="3425" marT="3425" marB="0" anchor="ctr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%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968</a:t>
                      </a:r>
                    </a:p>
                  </a:txBody>
                  <a:tcPr marL="3425" marR="3425" marT="3425" marB="0" anchor="ctr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%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28599655"/>
                  </a:ext>
                </a:extLst>
              </a:tr>
              <a:tr h="156281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C2</a:t>
                      </a:r>
                    </a:p>
                  </a:txBody>
                  <a:tcPr marL="3425" marR="3425" marT="3425" marB="0" anchor="ctr">
                    <a:lnL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.R273H</a:t>
                      </a:r>
                    </a:p>
                  </a:txBody>
                  <a:tcPr marL="3425" marR="3425" marT="34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577120 (C/T)</a:t>
                      </a:r>
                    </a:p>
                  </a:txBody>
                  <a:tcPr marL="3425" marR="3425" marT="3425" marB="0" anchor="ctr">
                    <a:lnL>
                      <a:noFill/>
                    </a:lnL>
                    <a:lnR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9,709</a:t>
                      </a:r>
                    </a:p>
                  </a:txBody>
                  <a:tcPr marL="3425" marR="3425" marT="3425" marB="0" anchor="ctr">
                    <a:lnL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,633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4%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3447</a:t>
                      </a:r>
                    </a:p>
                  </a:txBody>
                  <a:tcPr marL="3425" marR="3425" marT="3425" marB="0" anchor="ctr">
                    <a:lnL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%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675</a:t>
                      </a:r>
                    </a:p>
                  </a:txBody>
                  <a:tcPr marL="3425" marR="3425" marT="3425" marB="0" anchor="ctr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%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 gridSpan="2">
                  <a:txBody>
                    <a:bodyPr/>
                    <a:lstStyle/>
                    <a:p>
                      <a:pPr algn="ctr" fontAlgn="ctr"/>
                      <a:r>
                        <a:rPr lang="en-AU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t Analysed</a:t>
                      </a:r>
                    </a:p>
                  </a:txBody>
                  <a:tcPr marL="3425" marR="3425" marT="3425" marB="0" anchor="ctr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 rowSpan="2" h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500136365"/>
                  </a:ext>
                </a:extLst>
              </a:tr>
              <a:tr h="156281">
                <a:tc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.I195fs</a:t>
                      </a:r>
                    </a:p>
                  </a:txBody>
                  <a:tcPr marL="3425" marR="3425" marT="34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578265 (A/AT)</a:t>
                      </a:r>
                    </a:p>
                  </a:txBody>
                  <a:tcPr marL="3425" marR="3425" marT="3425" marB="0" anchor="ctr">
                    <a:lnL>
                      <a:noFill/>
                    </a:lnL>
                    <a:lnR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8,766</a:t>
                      </a:r>
                    </a:p>
                  </a:txBody>
                  <a:tcPr marL="3425" marR="3425" marT="3425" marB="0" anchor="ctr">
                    <a:lnL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496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%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3650</a:t>
                      </a:r>
                    </a:p>
                  </a:txBody>
                  <a:tcPr marL="3425" marR="3425" marT="3425" marB="0" anchor="ctr">
                    <a:lnL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%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952</a:t>
                      </a:r>
                    </a:p>
                  </a:txBody>
                  <a:tcPr marL="3425" marR="3425" marT="3425" marB="0" anchor="ctr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3%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21290039"/>
                  </a:ext>
                </a:extLst>
              </a:tr>
              <a:tr h="156281"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C3</a:t>
                      </a:r>
                    </a:p>
                  </a:txBody>
                  <a:tcPr marL="3425" marR="3425" marT="3425" marB="0" anchor="ctr">
                    <a:lnL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.N13N</a:t>
                      </a:r>
                    </a:p>
                  </a:txBody>
                  <a:tcPr marL="3425" marR="3425" marT="34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579757 (T/C)</a:t>
                      </a:r>
                    </a:p>
                  </a:txBody>
                  <a:tcPr marL="3425" marR="3425" marT="3425" marB="0" anchor="ctr">
                    <a:lnL>
                      <a:noFill/>
                    </a:lnL>
                    <a:lnR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AU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 coverage</a:t>
                      </a:r>
                    </a:p>
                  </a:txBody>
                  <a:tcPr marL="3425" marR="3425" marT="3425" marB="0" anchor="ctr">
                    <a:lnL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61</a:t>
                      </a:r>
                    </a:p>
                  </a:txBody>
                  <a:tcPr marL="3425" marR="3425" marT="3425" marB="0" anchor="ctr">
                    <a:lnL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0%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92</a:t>
                      </a:r>
                    </a:p>
                  </a:txBody>
                  <a:tcPr marL="3425" marR="3425" marT="3425" marB="0" anchor="ctr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%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3425" marR="3425" marT="3425" marB="0" anchor="ctr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83746730"/>
                  </a:ext>
                </a:extLst>
              </a:tr>
              <a:tr h="156281">
                <a:tc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AU" sz="8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.Y233C</a:t>
                      </a:r>
                    </a:p>
                  </a:txBody>
                  <a:tcPr marL="3425" marR="3425" marT="34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577583 (T/G)</a:t>
                      </a:r>
                    </a:p>
                  </a:txBody>
                  <a:tcPr marL="3425" marR="3425" marT="3425" marB="0" anchor="ctr">
                    <a:lnL>
                      <a:noFill/>
                    </a:lnL>
                    <a:lnR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8,690</a:t>
                      </a:r>
                    </a:p>
                  </a:txBody>
                  <a:tcPr marL="3425" marR="3425" marT="3425" marB="0" anchor="ctr">
                    <a:lnL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674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%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445</a:t>
                      </a:r>
                    </a:p>
                  </a:txBody>
                  <a:tcPr marL="3425" marR="3425" marT="3425" marB="0" anchor="ctr">
                    <a:lnL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%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64</a:t>
                      </a:r>
                    </a:p>
                  </a:txBody>
                  <a:tcPr marL="3425" marR="3425" marT="3425" marB="0" anchor="ctr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%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3425" marR="3425" marT="3425" marB="0" anchor="ctr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%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80005495"/>
                  </a:ext>
                </a:extLst>
              </a:tr>
              <a:tr h="156281">
                <a:tc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AU" sz="8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.I195T</a:t>
                      </a:r>
                    </a:p>
                  </a:txBody>
                  <a:tcPr marL="3425" marR="3425" marT="34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578265 (A/G)</a:t>
                      </a:r>
                    </a:p>
                  </a:txBody>
                  <a:tcPr marL="3425" marR="3425" marT="3425" marB="0" anchor="ctr">
                    <a:lnL>
                      <a:noFill/>
                    </a:lnL>
                    <a:lnR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C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2,277</a:t>
                      </a:r>
                    </a:p>
                  </a:txBody>
                  <a:tcPr marL="3425" marR="3425" marT="3425" marB="0" anchor="ctr">
                    <a:lnL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C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674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C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C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3%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C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3619</a:t>
                      </a:r>
                    </a:p>
                  </a:txBody>
                  <a:tcPr marL="3425" marR="3425" marT="3425" marB="0" anchor="ctr">
                    <a:lnL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%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BFBF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496</a:t>
                      </a:r>
                    </a:p>
                  </a:txBody>
                  <a:tcPr marL="3425" marR="3425" marT="3425" marB="0" anchor="ctr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C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1%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C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</a:t>
                      </a:r>
                    </a:p>
                  </a:txBody>
                  <a:tcPr marL="3425" marR="3425" marT="3425" marB="0" anchor="ctr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%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36149913"/>
                  </a:ext>
                </a:extLst>
              </a:tr>
              <a:tr h="156281">
                <a:tc rowSpan="9"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C4</a:t>
                      </a:r>
                    </a:p>
                  </a:txBody>
                  <a:tcPr marL="3425" marR="3425" marT="3425" marB="0" anchor="ctr">
                    <a:lnL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AU" sz="8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.R282W</a:t>
                      </a:r>
                    </a:p>
                  </a:txBody>
                  <a:tcPr marL="3425" marR="3425" marT="34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577094 (G/A)</a:t>
                      </a:r>
                    </a:p>
                  </a:txBody>
                  <a:tcPr marL="3425" marR="3425" marT="3425" marB="0" anchor="ctr">
                    <a:lnL>
                      <a:noFill/>
                    </a:lnL>
                    <a:lnR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0,058</a:t>
                      </a:r>
                    </a:p>
                  </a:txBody>
                  <a:tcPr marL="3425" marR="3425" marT="3425" marB="0" anchor="ctr">
                    <a:lnL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,971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0%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1873</a:t>
                      </a:r>
                    </a:p>
                  </a:txBody>
                  <a:tcPr marL="3425" marR="3425" marT="3425" marB="0" anchor="ctr">
                    <a:lnL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%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573</a:t>
                      </a:r>
                    </a:p>
                  </a:txBody>
                  <a:tcPr marL="3425" marR="3425" marT="3425" marB="0" anchor="ctr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%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361</a:t>
                      </a:r>
                    </a:p>
                  </a:txBody>
                  <a:tcPr marL="3425" marR="3425" marT="3425" marB="0" anchor="ctr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%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6691697"/>
                  </a:ext>
                </a:extLst>
              </a:tr>
              <a:tr h="156281">
                <a:tc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.R273L</a:t>
                      </a:r>
                    </a:p>
                  </a:txBody>
                  <a:tcPr marL="3425" marR="3425" marT="34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577120 (C/A)</a:t>
                      </a:r>
                    </a:p>
                  </a:txBody>
                  <a:tcPr marL="3425" marR="3425" marT="3425" marB="0" anchor="ctr">
                    <a:lnL>
                      <a:noFill/>
                    </a:lnL>
                    <a:lnR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0,058</a:t>
                      </a:r>
                    </a:p>
                  </a:txBody>
                  <a:tcPr marL="3425" marR="3425" marT="3425" marB="0" anchor="ctr">
                    <a:lnL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,971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0%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723</a:t>
                      </a:r>
                    </a:p>
                  </a:txBody>
                  <a:tcPr marL="3425" marR="3425" marT="3425" marB="0" anchor="ctr">
                    <a:lnL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%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570</a:t>
                      </a:r>
                    </a:p>
                  </a:txBody>
                  <a:tcPr marL="3425" marR="3425" marT="3425" marB="0" anchor="ctr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%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362</a:t>
                      </a:r>
                    </a:p>
                  </a:txBody>
                  <a:tcPr marL="3425" marR="3425" marT="3425" marB="0" anchor="ctr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%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78445493"/>
                  </a:ext>
                </a:extLst>
              </a:tr>
              <a:tr h="156281">
                <a:tc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AU" sz="8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.R248Q</a:t>
                      </a:r>
                    </a:p>
                  </a:txBody>
                  <a:tcPr marL="3425" marR="3425" marT="34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577538 (C/T)</a:t>
                      </a:r>
                    </a:p>
                  </a:txBody>
                  <a:tcPr marL="3425" marR="3425" marT="3425" marB="0" anchor="ctr">
                    <a:lnL>
                      <a:noFill/>
                    </a:lnL>
                    <a:lnR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3,440</a:t>
                      </a:r>
                    </a:p>
                  </a:txBody>
                  <a:tcPr marL="3425" marR="3425" marT="3425" marB="0" anchor="ctr">
                    <a:lnL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C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,096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C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C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6%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C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063</a:t>
                      </a:r>
                    </a:p>
                  </a:txBody>
                  <a:tcPr marL="3425" marR="3425" marT="3425" marB="0" anchor="ctr">
                    <a:lnL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C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0%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C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30</a:t>
                      </a:r>
                    </a:p>
                  </a:txBody>
                  <a:tcPr marL="3425" marR="3425" marT="3425" marB="0" anchor="ctr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C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%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C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485</a:t>
                      </a:r>
                    </a:p>
                  </a:txBody>
                  <a:tcPr marL="3425" marR="3425" marT="3425" marB="0" anchor="ctr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%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15868922"/>
                  </a:ext>
                </a:extLst>
              </a:tr>
              <a:tr h="156281">
                <a:tc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.C238Y</a:t>
                      </a:r>
                    </a:p>
                  </a:txBody>
                  <a:tcPr marL="3425" marR="3425" marT="34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577568 (C/T)</a:t>
                      </a:r>
                    </a:p>
                  </a:txBody>
                  <a:tcPr marL="3425" marR="3425" marT="3425" marB="0" anchor="ctr">
                    <a:lnL>
                      <a:noFill/>
                    </a:lnL>
                    <a:lnR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3,440</a:t>
                      </a:r>
                    </a:p>
                  </a:txBody>
                  <a:tcPr marL="3425" marR="3425" marT="3425" marB="0" anchor="ctr">
                    <a:lnL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,096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8%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051</a:t>
                      </a:r>
                    </a:p>
                  </a:txBody>
                  <a:tcPr marL="3425" marR="3425" marT="3425" marB="0" anchor="ctr">
                    <a:lnL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%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30</a:t>
                      </a:r>
                    </a:p>
                  </a:txBody>
                  <a:tcPr marL="3425" marR="3425" marT="3425" marB="0" anchor="ctr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%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356</a:t>
                      </a:r>
                    </a:p>
                  </a:txBody>
                  <a:tcPr marL="3425" marR="3425" marT="3425" marB="0" anchor="ctr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%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93968841"/>
                  </a:ext>
                </a:extLst>
              </a:tr>
              <a:tr h="156281">
                <a:tc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.M237I</a:t>
                      </a:r>
                    </a:p>
                  </a:txBody>
                  <a:tcPr marL="3425" marR="3425" marT="34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577570 (C/T)</a:t>
                      </a:r>
                    </a:p>
                  </a:txBody>
                  <a:tcPr marL="3425" marR="3425" marT="3425" marB="0" anchor="ctr">
                    <a:lnL>
                      <a:noFill/>
                    </a:lnL>
                    <a:lnR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3,440</a:t>
                      </a:r>
                    </a:p>
                  </a:txBody>
                  <a:tcPr marL="3425" marR="3425" marT="3425" marB="0" anchor="ctr">
                    <a:lnL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,096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4%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051</a:t>
                      </a:r>
                    </a:p>
                  </a:txBody>
                  <a:tcPr marL="3425" marR="3425" marT="3425" marB="0" anchor="ctr">
                    <a:lnL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%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30</a:t>
                      </a:r>
                    </a:p>
                  </a:txBody>
                  <a:tcPr marL="3425" marR="3425" marT="3425" marB="0" anchor="ctr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%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356</a:t>
                      </a:r>
                    </a:p>
                  </a:txBody>
                  <a:tcPr marL="3425" marR="3425" marT="3425" marB="0" anchor="ctr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%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29820993"/>
                  </a:ext>
                </a:extLst>
              </a:tr>
              <a:tr h="156281">
                <a:tc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.Y220C</a:t>
                      </a:r>
                    </a:p>
                  </a:txBody>
                  <a:tcPr marL="3425" marR="3425" marT="34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578190 (T/C)</a:t>
                      </a:r>
                    </a:p>
                  </a:txBody>
                  <a:tcPr marL="3425" marR="3425" marT="3425" marB="0" anchor="ctr">
                    <a:lnL>
                      <a:noFill/>
                    </a:lnL>
                    <a:lnR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9,458</a:t>
                      </a:r>
                    </a:p>
                  </a:txBody>
                  <a:tcPr marL="3425" marR="3425" marT="3425" marB="0" anchor="ctr">
                    <a:lnL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,773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8%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4491</a:t>
                      </a:r>
                    </a:p>
                  </a:txBody>
                  <a:tcPr marL="3425" marR="3425" marT="3425" marB="0" anchor="ctr">
                    <a:lnL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%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48</a:t>
                      </a:r>
                    </a:p>
                  </a:txBody>
                  <a:tcPr marL="3425" marR="3425" marT="3425" marB="0" anchor="ctr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%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676</a:t>
                      </a:r>
                    </a:p>
                  </a:txBody>
                  <a:tcPr marL="3425" marR="3425" marT="3425" marB="0" anchor="ctr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%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3393809"/>
                  </a:ext>
                </a:extLst>
              </a:tr>
              <a:tr h="156281">
                <a:tc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.V197G</a:t>
                      </a:r>
                    </a:p>
                  </a:txBody>
                  <a:tcPr marL="3425" marR="3425" marT="34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578259 (A/C)</a:t>
                      </a:r>
                    </a:p>
                  </a:txBody>
                  <a:tcPr marL="3425" marR="3425" marT="3425" marB="0" anchor="ctr">
                    <a:lnL>
                      <a:noFill/>
                    </a:lnL>
                    <a:lnR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0,911</a:t>
                      </a:r>
                    </a:p>
                  </a:txBody>
                  <a:tcPr marL="3425" marR="3425" marT="3425" marB="0" anchor="ctr">
                    <a:lnL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,833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6%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4491</a:t>
                      </a:r>
                    </a:p>
                  </a:txBody>
                  <a:tcPr marL="3425" marR="3425" marT="3425" marB="0" anchor="ctr">
                    <a:lnL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%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01</a:t>
                      </a:r>
                    </a:p>
                  </a:txBody>
                  <a:tcPr marL="3425" marR="3425" marT="3425" marB="0" anchor="ctr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%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798</a:t>
                      </a:r>
                    </a:p>
                  </a:txBody>
                  <a:tcPr marL="3425" marR="3425" marT="3425" marB="0" anchor="ctr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%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68701523"/>
                  </a:ext>
                </a:extLst>
              </a:tr>
              <a:tr h="156281">
                <a:tc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.R280S</a:t>
                      </a:r>
                    </a:p>
                  </a:txBody>
                  <a:tcPr marL="3425" marR="3425" marT="34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577100 (T/C)</a:t>
                      </a:r>
                    </a:p>
                  </a:txBody>
                  <a:tcPr marL="3425" marR="3425" marT="3425" marB="0" anchor="ctr">
                    <a:lnL>
                      <a:noFill/>
                    </a:lnL>
                    <a:lnR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0,058</a:t>
                      </a:r>
                    </a:p>
                  </a:txBody>
                  <a:tcPr marL="3425" marR="3425" marT="3425" marB="0" anchor="ctr">
                    <a:lnL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71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C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C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03%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C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1873</a:t>
                      </a:r>
                    </a:p>
                  </a:txBody>
                  <a:tcPr marL="3425" marR="3425" marT="3425" marB="0" anchor="ctr">
                    <a:lnL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C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%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C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573</a:t>
                      </a:r>
                    </a:p>
                  </a:txBody>
                  <a:tcPr marL="3425" marR="3425" marT="3425" marB="0" anchor="ctr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%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361</a:t>
                      </a:r>
                    </a:p>
                  </a:txBody>
                  <a:tcPr marL="3425" marR="3425" marT="3425" marB="0" anchor="ctr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%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2421784"/>
                  </a:ext>
                </a:extLst>
              </a:tr>
              <a:tr h="156281">
                <a:tc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.I255F</a:t>
                      </a:r>
                    </a:p>
                  </a:txBody>
                  <a:tcPr marL="3425" marR="3425" marT="34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577518 (T/A)</a:t>
                      </a:r>
                    </a:p>
                  </a:txBody>
                  <a:tcPr marL="3425" marR="3425" marT="3425" marB="0" anchor="ctr">
                    <a:lnL>
                      <a:noFill/>
                    </a:lnL>
                    <a:lnR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3,440</a:t>
                      </a:r>
                    </a:p>
                  </a:txBody>
                  <a:tcPr marL="3425" marR="3425" marT="3425" marB="0" anchor="ctr">
                    <a:lnL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96</a:t>
                      </a:r>
                    </a:p>
                  </a:txBody>
                  <a:tcPr marL="3425" marR="3425" marT="34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3425" marR="3425" marT="34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%</a:t>
                      </a:r>
                    </a:p>
                  </a:txBody>
                  <a:tcPr marL="3425" marR="3425" marT="3425" marB="0" anchor="ctr">
                    <a:lnL>
                      <a:noFill/>
                    </a:lnL>
                    <a:lnR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063</a:t>
                      </a:r>
                    </a:p>
                  </a:txBody>
                  <a:tcPr marL="3425" marR="3425" marT="3425" marB="0" anchor="ctr">
                    <a:lnL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%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96</a:t>
                      </a:r>
                    </a:p>
                  </a:txBody>
                  <a:tcPr marL="3425" marR="3425" marT="3425" marB="0" anchor="ctr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5%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129</a:t>
                      </a:r>
                    </a:p>
                  </a:txBody>
                  <a:tcPr marL="3425" marR="3425" marT="3425" marB="0" anchor="ctr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%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2954587"/>
                  </a:ext>
                </a:extLst>
              </a:tr>
              <a:tr h="156281">
                <a:tc rowSpan="5"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C5</a:t>
                      </a:r>
                    </a:p>
                  </a:txBody>
                  <a:tcPr marL="3425" marR="3425" marT="3425" marB="0" anchor="ctr">
                    <a:lnL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.T253P</a:t>
                      </a:r>
                    </a:p>
                  </a:txBody>
                  <a:tcPr marL="3425" marR="3425" marT="34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577524 (T/C)</a:t>
                      </a:r>
                    </a:p>
                  </a:txBody>
                  <a:tcPr marL="3425" marR="3425" marT="3425" marB="0" anchor="ctr">
                    <a:lnL>
                      <a:noFill/>
                    </a:lnL>
                    <a:lnR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9773</a:t>
                      </a:r>
                    </a:p>
                  </a:txBody>
                  <a:tcPr marL="3425" marR="3425" marT="3425" marB="0" anchor="ctr">
                    <a:lnL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490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%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3936</a:t>
                      </a:r>
                    </a:p>
                  </a:txBody>
                  <a:tcPr marL="3425" marR="3425" marT="3425" marB="0" anchor="ctr">
                    <a:lnL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0%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133</a:t>
                      </a:r>
                    </a:p>
                  </a:txBody>
                  <a:tcPr marL="3425" marR="3425" marT="3425" marB="0" anchor="ctr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%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5" gridSpan="2">
                  <a:txBody>
                    <a:bodyPr/>
                    <a:lstStyle/>
                    <a:p>
                      <a:pPr algn="ctr" fontAlgn="ctr"/>
                      <a:r>
                        <a:rPr lang="en-AU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t Analysed</a:t>
                      </a:r>
                    </a:p>
                  </a:txBody>
                  <a:tcPr marL="3425" marR="3425" marT="3425" marB="0" anchor="ctr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 rowSpan="5" h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00523872"/>
                  </a:ext>
                </a:extLst>
              </a:tr>
              <a:tr h="156281">
                <a:tc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AU" sz="8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.R282W</a:t>
                      </a:r>
                    </a:p>
                  </a:txBody>
                  <a:tcPr marL="3425" marR="3425" marT="34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577094 (G/A)</a:t>
                      </a:r>
                    </a:p>
                  </a:txBody>
                  <a:tcPr marL="3425" marR="3425" marT="3425" marB="0" anchor="ctr">
                    <a:lnL>
                      <a:noFill/>
                    </a:lnL>
                    <a:lnR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7,306</a:t>
                      </a:r>
                    </a:p>
                  </a:txBody>
                  <a:tcPr marL="3425" marR="3425" marT="3425" marB="0" anchor="ctr">
                    <a:lnL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,614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4%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8544</a:t>
                      </a:r>
                    </a:p>
                  </a:txBody>
                  <a:tcPr marL="3425" marR="3425" marT="3425" marB="0" anchor="ctr">
                    <a:lnL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%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6291</a:t>
                      </a:r>
                    </a:p>
                  </a:txBody>
                  <a:tcPr marL="3425" marR="3425" marT="3425" marB="0" anchor="ctr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%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852630162"/>
                  </a:ext>
                </a:extLst>
              </a:tr>
              <a:tr h="156281">
                <a:tc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AU" sz="8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.I195T</a:t>
                      </a:r>
                    </a:p>
                  </a:txBody>
                  <a:tcPr marL="3425" marR="3425" marT="34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578265 (A/G)</a:t>
                      </a:r>
                    </a:p>
                  </a:txBody>
                  <a:tcPr marL="3425" marR="3425" marT="3425" marB="0" anchor="ctr">
                    <a:lnL>
                      <a:noFill/>
                    </a:lnL>
                    <a:lnR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C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0,382</a:t>
                      </a:r>
                    </a:p>
                  </a:txBody>
                  <a:tcPr marL="3425" marR="3425" marT="3425" marB="0" anchor="ctr">
                    <a:lnL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C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,427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C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8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C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6%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C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7999</a:t>
                      </a:r>
                    </a:p>
                  </a:txBody>
                  <a:tcPr marL="3425" marR="3425" marT="3425" marB="0" anchor="ctr">
                    <a:lnL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C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0%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C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874</a:t>
                      </a:r>
                    </a:p>
                  </a:txBody>
                  <a:tcPr marL="3425" marR="3425" marT="3425" marB="0" anchor="ctr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%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344373902"/>
                  </a:ext>
                </a:extLst>
              </a:tr>
              <a:tr h="156281">
                <a:tc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.V157I</a:t>
                      </a:r>
                    </a:p>
                  </a:txBody>
                  <a:tcPr marL="3425" marR="3425" marT="34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578461 (C/T)</a:t>
                      </a:r>
                    </a:p>
                  </a:txBody>
                  <a:tcPr marL="3425" marR="3425" marT="3425" marB="0" anchor="ctr">
                    <a:lnL>
                      <a:noFill/>
                    </a:lnL>
                    <a:lnR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9,667</a:t>
                      </a:r>
                    </a:p>
                  </a:txBody>
                  <a:tcPr marL="3425" marR="3425" marT="3425" marB="0" anchor="ctr">
                    <a:lnL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,489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4%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8694</a:t>
                      </a:r>
                    </a:p>
                  </a:txBody>
                  <a:tcPr marL="3425" marR="3425" marT="3425" marB="0" anchor="ctr">
                    <a:lnL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%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061</a:t>
                      </a:r>
                    </a:p>
                  </a:txBody>
                  <a:tcPr marL="3425" marR="3425" marT="3425" marB="0" anchor="ctr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%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13950296"/>
                  </a:ext>
                </a:extLst>
              </a:tr>
              <a:tr h="156281">
                <a:tc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.P151S</a:t>
                      </a:r>
                    </a:p>
                  </a:txBody>
                  <a:tcPr marL="3425" marR="3425" marT="34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578479 (G/A)</a:t>
                      </a:r>
                    </a:p>
                  </a:txBody>
                  <a:tcPr marL="3425" marR="3425" marT="3425" marB="0" anchor="ctr">
                    <a:lnL>
                      <a:noFill/>
                    </a:lnL>
                    <a:lnR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9,773</a:t>
                      </a:r>
                    </a:p>
                  </a:txBody>
                  <a:tcPr marL="3425" marR="3425" marT="3425" marB="0" anchor="ctr">
                    <a:lnL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,490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4%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8686</a:t>
                      </a:r>
                    </a:p>
                  </a:txBody>
                  <a:tcPr marL="3425" marR="3425" marT="3425" marB="0" anchor="ctr">
                    <a:lnL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%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061</a:t>
                      </a:r>
                    </a:p>
                  </a:txBody>
                  <a:tcPr marL="3425" marR="3425" marT="3425" marB="0" anchor="ctr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%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81234154"/>
                  </a:ext>
                </a:extLst>
              </a:tr>
              <a:tr h="156281"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C6</a:t>
                      </a:r>
                    </a:p>
                  </a:txBody>
                  <a:tcPr marL="3425" marR="3425" marT="3425" marB="0" anchor="ctr">
                    <a:lnL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AU" sz="8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.G266R</a:t>
                      </a:r>
                    </a:p>
                  </a:txBody>
                  <a:tcPr marL="3425" marR="3425" marT="34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577142 (C/T)</a:t>
                      </a:r>
                    </a:p>
                  </a:txBody>
                  <a:tcPr marL="3425" marR="3425" marT="3425" marB="0" anchor="ctr">
                    <a:lnL>
                      <a:noFill/>
                    </a:lnL>
                    <a:lnR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9,991</a:t>
                      </a:r>
                    </a:p>
                  </a:txBody>
                  <a:tcPr marL="3425" marR="3425" marT="3425" marB="0" anchor="ctr">
                    <a:lnL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765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4%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378</a:t>
                      </a:r>
                    </a:p>
                  </a:txBody>
                  <a:tcPr marL="3425" marR="3425" marT="3425" marB="0" anchor="ctr">
                    <a:lnL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%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99</a:t>
                      </a:r>
                    </a:p>
                  </a:txBody>
                  <a:tcPr marL="3425" marR="3425" marT="3425" marB="0" anchor="ctr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%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 gridSpan="2">
                  <a:txBody>
                    <a:bodyPr/>
                    <a:lstStyle/>
                    <a:p>
                      <a:pPr algn="ctr" fontAlgn="ctr"/>
                      <a:r>
                        <a:rPr lang="en-AU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t Analysed</a:t>
                      </a:r>
                    </a:p>
                  </a:txBody>
                  <a:tcPr marL="3425" marR="3425" marT="3425" marB="0" anchor="ctr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 rowSpan="3" h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399044231"/>
                  </a:ext>
                </a:extLst>
              </a:tr>
              <a:tr h="156281">
                <a:tc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AU" sz="8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.R248Q</a:t>
                      </a:r>
                    </a:p>
                  </a:txBody>
                  <a:tcPr marL="3425" marR="3425" marT="34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577538 (A/C)</a:t>
                      </a:r>
                    </a:p>
                  </a:txBody>
                  <a:tcPr marL="3425" marR="3425" marT="3425" marB="0" anchor="ctr">
                    <a:lnL>
                      <a:noFill/>
                    </a:lnL>
                    <a:lnR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3,026</a:t>
                      </a:r>
                    </a:p>
                  </a:txBody>
                  <a:tcPr marL="3425" marR="3425" marT="3425" marB="0" anchor="ctr">
                    <a:lnL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921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%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6275</a:t>
                      </a:r>
                    </a:p>
                  </a:txBody>
                  <a:tcPr marL="3425" marR="3425" marT="3425" marB="0" anchor="ctr">
                    <a:lnL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%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18</a:t>
                      </a:r>
                    </a:p>
                  </a:txBody>
                  <a:tcPr marL="3425" marR="3425" marT="3425" marB="0" anchor="ctr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%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56287020"/>
                  </a:ext>
                </a:extLst>
              </a:tr>
              <a:tr h="156281">
                <a:tc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.C238R</a:t>
                      </a:r>
                    </a:p>
                  </a:txBody>
                  <a:tcPr marL="3425" marR="3425" marT="34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577569 (A/G)</a:t>
                      </a:r>
                    </a:p>
                  </a:txBody>
                  <a:tcPr marL="3425" marR="3425" marT="3425" marB="0" anchor="ctr">
                    <a:lnL>
                      <a:noFill/>
                    </a:lnL>
                    <a:lnR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3,036</a:t>
                      </a:r>
                    </a:p>
                  </a:txBody>
                  <a:tcPr marL="3425" marR="3425" marT="3425" marB="0" anchor="ctr">
                    <a:lnL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,921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%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341</a:t>
                      </a:r>
                    </a:p>
                  </a:txBody>
                  <a:tcPr marL="3425" marR="3425" marT="3425" marB="0" anchor="ctr">
                    <a:lnL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%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18</a:t>
                      </a:r>
                    </a:p>
                  </a:txBody>
                  <a:tcPr marL="3425" marR="3425" marT="3425" marB="0" anchor="ctr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%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790309905"/>
                  </a:ext>
                </a:extLst>
              </a:tr>
              <a:tr h="156281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C7</a:t>
                      </a:r>
                    </a:p>
                  </a:txBody>
                  <a:tcPr marL="3425" marR="3425" marT="3425" marB="0" anchor="ctr">
                    <a:lnL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AU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.S378fs</a:t>
                      </a:r>
                    </a:p>
                  </a:txBody>
                  <a:tcPr marL="3425" marR="3425" marT="34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572976 (G/GT)</a:t>
                      </a:r>
                    </a:p>
                  </a:txBody>
                  <a:tcPr marL="3425" marR="3425" marT="3425" marB="0" anchor="ctr">
                    <a:lnL>
                      <a:noFill/>
                    </a:lnL>
                    <a:lnR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5488</a:t>
                      </a:r>
                    </a:p>
                  </a:txBody>
                  <a:tcPr marL="3425" marR="3425" marT="3425" marB="0" anchor="ctr">
                    <a:lnL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345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8%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908</a:t>
                      </a:r>
                    </a:p>
                  </a:txBody>
                  <a:tcPr marL="3425" marR="3425" marT="3425" marB="0" anchor="ctr">
                    <a:lnL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%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910</a:t>
                      </a:r>
                    </a:p>
                  </a:txBody>
                  <a:tcPr marL="3425" marR="3425" marT="3425" marB="0" anchor="ctr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%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938</a:t>
                      </a:r>
                    </a:p>
                  </a:txBody>
                  <a:tcPr marL="3425" marR="3425" marT="3425" marB="0" anchor="ctr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%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36246604"/>
                  </a:ext>
                </a:extLst>
              </a:tr>
              <a:tr h="156281">
                <a:tc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AU" sz="800" b="1" i="0" u="none" strike="noStrike">
                          <a:solidFill>
                            <a:srgbClr val="00B0F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RAS p.G12D</a:t>
                      </a:r>
                    </a:p>
                  </a:txBody>
                  <a:tcPr marL="3425" marR="3425" marT="34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1" i="0" u="none" strike="noStrike" dirty="0">
                          <a:solidFill>
                            <a:srgbClr val="00B0F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r12:25398284 (G/A)</a:t>
                      </a:r>
                    </a:p>
                  </a:txBody>
                  <a:tcPr marL="3425" marR="3425" marT="3425" marB="0" anchor="ctr">
                    <a:lnL>
                      <a:noFill/>
                    </a:lnL>
                    <a:lnR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1" i="0" u="none" strike="noStrike">
                          <a:solidFill>
                            <a:srgbClr val="00B0F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6881</a:t>
                      </a:r>
                    </a:p>
                  </a:txBody>
                  <a:tcPr marL="3425" marR="3425" marT="3425" marB="0" anchor="ctr">
                    <a:lnL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1" i="0" u="none" strike="noStrike">
                          <a:solidFill>
                            <a:srgbClr val="00B0F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43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1" i="0" u="none" strike="noStrike">
                          <a:solidFill>
                            <a:srgbClr val="00B0F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1" i="0" u="none" strike="noStrike">
                          <a:solidFill>
                            <a:srgbClr val="00B0F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2%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3425" marR="3425" marT="3425" marB="0" anchor="ctr">
                    <a:lnL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3425" marR="3425" marT="3425" marB="0" anchor="ctr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3425" marR="3425" marT="3425" marB="0" anchor="ctr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6769342"/>
                  </a:ext>
                </a:extLst>
              </a:tr>
              <a:tr h="156281"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C8</a:t>
                      </a:r>
                    </a:p>
                  </a:txBody>
                  <a:tcPr marL="3425" marR="3425" marT="3425" marB="0" anchor="ctr">
                    <a:lnL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.R196Q</a:t>
                      </a:r>
                    </a:p>
                  </a:txBody>
                  <a:tcPr marL="3425" marR="3425" marT="34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578262 (C/T)</a:t>
                      </a:r>
                    </a:p>
                  </a:txBody>
                  <a:tcPr marL="3425" marR="3425" marT="3425" marB="0" anchor="ctr">
                    <a:lnL>
                      <a:noFill/>
                    </a:lnL>
                    <a:lnR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,181</a:t>
                      </a:r>
                    </a:p>
                  </a:txBody>
                  <a:tcPr marL="3425" marR="3425" marT="3425" marB="0" anchor="ctr">
                    <a:lnL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81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9%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031</a:t>
                      </a:r>
                    </a:p>
                  </a:txBody>
                  <a:tcPr marL="3425" marR="3425" marT="3425" marB="0" anchor="ctr">
                    <a:lnL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%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549</a:t>
                      </a:r>
                    </a:p>
                  </a:txBody>
                  <a:tcPr marL="3425" marR="3425" marT="3425" marB="0" anchor="ctr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%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4" gridSpan="2">
                  <a:txBody>
                    <a:bodyPr/>
                    <a:lstStyle/>
                    <a:p>
                      <a:pPr algn="ctr" fontAlgn="ctr"/>
                      <a:r>
                        <a:rPr lang="en-AU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t Analysed</a:t>
                      </a:r>
                    </a:p>
                  </a:txBody>
                  <a:tcPr marL="3425" marR="3425" marT="3425" marB="0" anchor="ctr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 rowSpan="4" h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68498667"/>
                  </a:ext>
                </a:extLst>
              </a:tr>
              <a:tr h="156281">
                <a:tc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.S215G</a:t>
                      </a:r>
                    </a:p>
                  </a:txBody>
                  <a:tcPr marL="3425" marR="3425" marT="34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578206 (T/C)</a:t>
                      </a:r>
                    </a:p>
                  </a:txBody>
                  <a:tcPr marL="3425" marR="3425" marT="3425" marB="0" anchor="ctr">
                    <a:lnL>
                      <a:noFill/>
                    </a:lnL>
                    <a:lnR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,524</a:t>
                      </a:r>
                    </a:p>
                  </a:txBody>
                  <a:tcPr marL="3425" marR="3425" marT="3425" marB="0" anchor="ctr">
                    <a:lnL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23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%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604</a:t>
                      </a:r>
                    </a:p>
                  </a:txBody>
                  <a:tcPr marL="3425" marR="3425" marT="3425" marB="0" anchor="ctr">
                    <a:lnL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%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27</a:t>
                      </a:r>
                    </a:p>
                  </a:txBody>
                  <a:tcPr marL="3425" marR="3425" marT="3425" marB="0" anchor="ctr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3%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562262826"/>
                  </a:ext>
                </a:extLst>
              </a:tr>
              <a:tr h="156281">
                <a:tc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.S185G</a:t>
                      </a:r>
                    </a:p>
                  </a:txBody>
                  <a:tcPr marL="3425" marR="3425" marT="34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578377 (T/G)</a:t>
                      </a:r>
                    </a:p>
                  </a:txBody>
                  <a:tcPr marL="3425" marR="3425" marT="3425" marB="0" anchor="ctr">
                    <a:lnL>
                      <a:noFill/>
                    </a:lnL>
                    <a:lnR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,021</a:t>
                      </a:r>
                    </a:p>
                  </a:txBody>
                  <a:tcPr marL="3425" marR="3425" marT="3425" marB="0" anchor="ctr">
                    <a:lnL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42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0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% 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839</a:t>
                      </a:r>
                    </a:p>
                  </a:txBody>
                  <a:tcPr marL="3425" marR="3425" marT="3425" marB="0" anchor="ctr">
                    <a:lnL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0%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918</a:t>
                      </a:r>
                    </a:p>
                  </a:txBody>
                  <a:tcPr marL="3425" marR="3425" marT="3425" marB="0" anchor="ctr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%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950369908"/>
                  </a:ext>
                </a:extLst>
              </a:tr>
              <a:tr h="156281">
                <a:tc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.D184H</a:t>
                      </a:r>
                    </a:p>
                  </a:txBody>
                  <a:tcPr marL="3425" marR="3425" marT="34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578380 (C/G)</a:t>
                      </a:r>
                    </a:p>
                  </a:txBody>
                  <a:tcPr marL="3425" marR="3425" marT="3425" marB="0" anchor="ctr">
                    <a:lnL>
                      <a:noFill/>
                    </a:lnL>
                    <a:lnR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,021</a:t>
                      </a:r>
                    </a:p>
                  </a:txBody>
                  <a:tcPr marL="3425" marR="3425" marT="3425" marB="0" anchor="ctr">
                    <a:lnL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,742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0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% 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838</a:t>
                      </a:r>
                    </a:p>
                  </a:txBody>
                  <a:tcPr marL="3425" marR="3425" marT="3425" marB="0" anchor="ctr">
                    <a:lnL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0%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918</a:t>
                      </a:r>
                    </a:p>
                  </a:txBody>
                  <a:tcPr marL="3425" marR="3425" marT="3425" marB="0" anchor="ctr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%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45378298"/>
                  </a:ext>
                </a:extLst>
              </a:tr>
              <a:tr h="156281"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C9</a:t>
                      </a:r>
                    </a:p>
                  </a:txBody>
                  <a:tcPr marL="3425" marR="3425" marT="3425" marB="0" anchor="ctr">
                    <a:lnL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.Y234C</a:t>
                      </a:r>
                    </a:p>
                  </a:txBody>
                  <a:tcPr marL="3425" marR="3425" marT="34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577580 (T/C)</a:t>
                      </a:r>
                    </a:p>
                  </a:txBody>
                  <a:tcPr marL="3425" marR="3425" marT="3425" marB="0" anchor="ctr">
                    <a:lnL>
                      <a:noFill/>
                    </a:lnL>
                    <a:lnR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0,889</a:t>
                      </a:r>
                    </a:p>
                  </a:txBody>
                  <a:tcPr marL="3425" marR="3425" marT="3425" marB="0" anchor="ctr">
                    <a:lnL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91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4%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150</a:t>
                      </a:r>
                    </a:p>
                  </a:txBody>
                  <a:tcPr marL="3425" marR="3425" marT="3425" marB="0" anchor="ctr">
                    <a:lnL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%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4</a:t>
                      </a:r>
                    </a:p>
                  </a:txBody>
                  <a:tcPr marL="3425" marR="3425" marT="3425" marB="0" anchor="ctr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%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742</a:t>
                      </a:r>
                    </a:p>
                  </a:txBody>
                  <a:tcPr marL="3425" marR="3425" marT="3425" marB="0" anchor="ctr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%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76781719"/>
                  </a:ext>
                </a:extLst>
              </a:tr>
              <a:tr h="156281">
                <a:tc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AU" sz="8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.R248Q</a:t>
                      </a:r>
                    </a:p>
                  </a:txBody>
                  <a:tcPr marL="3425" marR="3425" marT="34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579538 (A/C)</a:t>
                      </a:r>
                    </a:p>
                  </a:txBody>
                  <a:tcPr marL="3425" marR="3425" marT="3425" marB="0" anchor="ctr">
                    <a:lnL>
                      <a:noFill/>
                    </a:lnL>
                    <a:lnR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0,889</a:t>
                      </a:r>
                    </a:p>
                  </a:txBody>
                  <a:tcPr marL="3425" marR="3425" marT="3425" marB="0" anchor="ctr">
                    <a:lnL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91</a:t>
                      </a:r>
                    </a:p>
                  </a:txBody>
                  <a:tcPr marL="3425" marR="3425" marT="34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3425" marR="3425" marT="3425" marB="0" anchor="ctr">
                    <a:lnL>
                      <a:noFill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%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734</a:t>
                      </a:r>
                    </a:p>
                  </a:txBody>
                  <a:tcPr marL="3425" marR="3425" marT="3425" marB="0" anchor="ctr">
                    <a:lnL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%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48</a:t>
                      </a:r>
                    </a:p>
                  </a:txBody>
                  <a:tcPr marL="3425" marR="3425" marT="3425" marB="0" anchor="ctr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%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801</a:t>
                      </a:r>
                    </a:p>
                  </a:txBody>
                  <a:tcPr marL="3425" marR="3425" marT="3425" marB="0" anchor="ctr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%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47192402"/>
                  </a:ext>
                </a:extLst>
              </a:tr>
              <a:tr h="362946">
                <a:tc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.P177_C182del</a:t>
                      </a:r>
                    </a:p>
                  </a:txBody>
                  <a:tcPr marL="3425" marR="3425" marT="34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578383 (GCAGCGCTCATGGTGGGG/G)</a:t>
                      </a:r>
                    </a:p>
                  </a:txBody>
                  <a:tcPr marL="3425" marR="3425" marT="3425" marB="0" anchor="ctr">
                    <a:lnL>
                      <a:noFill/>
                    </a:lnL>
                    <a:lnR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,887</a:t>
                      </a:r>
                    </a:p>
                  </a:txBody>
                  <a:tcPr marL="3425" marR="3425" marT="3425" marB="0" anchor="ctr">
                    <a:lnL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,966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%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248</a:t>
                      </a:r>
                    </a:p>
                  </a:txBody>
                  <a:tcPr marL="3425" marR="3425" marT="3425" marB="0" anchor="ctr">
                    <a:lnL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%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73</a:t>
                      </a:r>
                    </a:p>
                  </a:txBody>
                  <a:tcPr marL="3425" marR="3425" marT="3425" marB="0" anchor="ctr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9%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270</a:t>
                      </a:r>
                    </a:p>
                  </a:txBody>
                  <a:tcPr marL="3425" marR="3425" marT="3425" marB="0" anchor="ctr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%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09215670"/>
                  </a:ext>
                </a:extLst>
              </a:tr>
              <a:tr h="156281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C10</a:t>
                      </a:r>
                    </a:p>
                  </a:txBody>
                  <a:tcPr marL="3425" marR="3425" marT="3425" marB="0" anchor="ctr">
                    <a:lnL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.R273C</a:t>
                      </a:r>
                    </a:p>
                  </a:txBody>
                  <a:tcPr marL="3425" marR="3425" marT="34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577121 (G/A)</a:t>
                      </a:r>
                    </a:p>
                  </a:txBody>
                  <a:tcPr marL="3425" marR="3425" marT="3425" marB="0" anchor="ctr">
                    <a:lnL>
                      <a:noFill/>
                    </a:lnL>
                    <a:lnR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CC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6,999</a:t>
                      </a:r>
                    </a:p>
                  </a:txBody>
                  <a:tcPr marL="3425" marR="3425" marT="3425" marB="0" anchor="ctr">
                    <a:lnL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C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,613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C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C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5%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C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4642</a:t>
                      </a:r>
                    </a:p>
                  </a:txBody>
                  <a:tcPr marL="3425" marR="3425" marT="3425" marB="0" anchor="ctr">
                    <a:lnL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C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7%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C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8,824</a:t>
                      </a:r>
                    </a:p>
                  </a:txBody>
                  <a:tcPr marL="3425" marR="3425" marT="3425" marB="0" anchor="ctr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C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7%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C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,257</a:t>
                      </a:r>
                    </a:p>
                  </a:txBody>
                  <a:tcPr marL="3425" marR="3425" marT="3425" marB="0" anchor="ctr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%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23464274"/>
                  </a:ext>
                </a:extLst>
              </a:tr>
              <a:tr h="156281">
                <a:tc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AU" sz="800" b="0" i="0" u="none" strike="noStrike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.I251M</a:t>
                      </a:r>
                    </a:p>
                  </a:txBody>
                  <a:tcPr marL="3425" marR="3425" marT="34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577528 (G/C)</a:t>
                      </a:r>
                    </a:p>
                  </a:txBody>
                  <a:tcPr marL="3425" marR="3425" marT="3425" marB="0" anchor="ctr">
                    <a:lnL>
                      <a:noFill/>
                    </a:lnL>
                    <a:lnR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,021</a:t>
                      </a:r>
                    </a:p>
                  </a:txBody>
                  <a:tcPr marL="3425" marR="3425" marT="3425" marB="0" anchor="ctr">
                    <a:lnL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,742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%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964</a:t>
                      </a:r>
                    </a:p>
                  </a:txBody>
                  <a:tcPr marL="3425" marR="3425" marT="3425" marB="0" anchor="ctr">
                    <a:lnL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0%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123</a:t>
                      </a:r>
                    </a:p>
                  </a:txBody>
                  <a:tcPr marL="3425" marR="3425" marT="3425" marB="0" anchor="ctr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%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365</a:t>
                      </a:r>
                    </a:p>
                  </a:txBody>
                  <a:tcPr marL="3425" marR="3425" marT="3425" marB="0" anchor="ctr">
                    <a:lnL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AU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%</a:t>
                      </a:r>
                    </a:p>
                  </a:txBody>
                  <a:tcPr marL="3425" marR="3425" marT="3425" marB="0" anchor="ctr">
                    <a:lnL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64671001"/>
                  </a:ext>
                </a:extLst>
              </a:tr>
              <a:tr h="198629">
                <a:tc gridSpan="13">
                  <a:txBody>
                    <a:bodyPr/>
                    <a:lstStyle/>
                    <a:p>
                      <a:pPr algn="l" fontAlgn="ctr"/>
                      <a:r>
                        <a:rPr lang="en-AU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Red text – discordance; salmon highlight – concordance; blue text – only covered by </a:t>
                      </a:r>
                      <a:r>
                        <a:rPr lang="en-AU" sz="8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ncomine</a:t>
                      </a:r>
                      <a:r>
                        <a:rPr lang="en-AU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; grey highlight – below threshold.</a:t>
                      </a:r>
                    </a:p>
                  </a:txBody>
                  <a:tcPr marL="3425" marR="3425" marT="34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84138313"/>
                  </a:ext>
                </a:extLst>
              </a:tr>
            </a:tbl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ECD7D4B6-95FA-52A2-8B20-DCE00B2DF2C7}"/>
              </a:ext>
            </a:extLst>
          </p:cNvPr>
          <p:cNvSpPr txBox="1"/>
          <p:nvPr/>
        </p:nvSpPr>
        <p:spPr>
          <a:xfrm>
            <a:off x="0" y="65055"/>
            <a:ext cx="5668539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S1: Somatic mutations identified in tissue and </a:t>
            </a:r>
            <a:r>
              <a:rPr lang="en-GB" sz="105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fDNA</a:t>
            </a:r>
            <a:r>
              <a:rPr lang="en-GB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using the </a:t>
            </a:r>
            <a:r>
              <a:rPr lang="en-GB" sz="105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ncomine</a:t>
            </a:r>
            <a:r>
              <a:rPr lang="en-GB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r Accel NGS. </a:t>
            </a:r>
          </a:p>
        </p:txBody>
      </p:sp>
    </p:spTree>
    <p:extLst>
      <p:ext uri="{BB962C8B-B14F-4D97-AF65-F5344CB8AC3E}">
        <p14:creationId xmlns:p14="http://schemas.microsoft.com/office/powerpoint/2010/main" val="220580992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1644ACC3-B3E4-40B8-86CD-C16254A5BA2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19784940"/>
              </p:ext>
            </p:extLst>
          </p:nvPr>
        </p:nvGraphicFramePr>
        <p:xfrm>
          <a:off x="3575050" y="1834515"/>
          <a:ext cx="5041900" cy="3188970"/>
        </p:xfrm>
        <a:graphic>
          <a:graphicData uri="http://schemas.openxmlformats.org/drawingml/2006/table">
            <a:tbl>
              <a:tblPr/>
              <a:tblGrid>
                <a:gridCol w="1894282">
                  <a:extLst>
                    <a:ext uri="{9D8B030D-6E8A-4147-A177-3AD203B41FA5}">
                      <a16:colId xmlns:a16="http://schemas.microsoft.com/office/drawing/2014/main" val="3465838464"/>
                    </a:ext>
                  </a:extLst>
                </a:gridCol>
                <a:gridCol w="1573809">
                  <a:extLst>
                    <a:ext uri="{9D8B030D-6E8A-4147-A177-3AD203B41FA5}">
                      <a16:colId xmlns:a16="http://schemas.microsoft.com/office/drawing/2014/main" val="2951264742"/>
                    </a:ext>
                  </a:extLst>
                </a:gridCol>
                <a:gridCol w="1573809">
                  <a:extLst>
                    <a:ext uri="{9D8B030D-6E8A-4147-A177-3AD203B41FA5}">
                      <a16:colId xmlns:a16="http://schemas.microsoft.com/office/drawing/2014/main" val="3798968200"/>
                    </a:ext>
                  </a:extLst>
                </a:gridCol>
              </a:tblGrid>
              <a:tr h="200025">
                <a:tc gridSpan="3">
                  <a:txBody>
                    <a:bodyPr/>
                    <a:lstStyle/>
                    <a:p>
                      <a:pPr algn="l" rtl="0" fontAlgn="ctr"/>
                      <a:r>
                        <a:rPr lang="en-GB" sz="116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Table S2: Comparison of product specification between </a:t>
                      </a:r>
                      <a:r>
                        <a:rPr lang="en-GB" sz="116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Oncomine</a:t>
                      </a:r>
                      <a:r>
                        <a:rPr lang="en-GB" sz="116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 and Accel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138837041"/>
                  </a:ext>
                </a:extLst>
              </a:tr>
              <a:tr h="190500"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AU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Variables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AU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Oncomin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AU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Swift Comprehensiv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45632761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AU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Panel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AU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 TP53 Panel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04246714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rtl="0" fontAlgn="ctr"/>
                      <a:r>
                        <a:rPr lang="en-AU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TP53 coverage (exons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AU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~80%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AU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0%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88011746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rtl="0" fontAlgn="ctr"/>
                      <a:r>
                        <a:rPr lang="en-AU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Number of </a:t>
                      </a:r>
                      <a:r>
                        <a:rPr lang="en-AU" sz="1000" b="1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TP53</a:t>
                      </a:r>
                      <a:r>
                        <a:rPr lang="en-AU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 amplicon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AU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AU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4086388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Total number of amplicons in panel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AU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5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AU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6910632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rtl="0" fontAlgn="ctr"/>
                      <a:r>
                        <a:rPr lang="en-AU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mplicon size (avg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AU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70 bp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AU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40 bp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0630544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rtl="0" fontAlgn="ctr"/>
                      <a:r>
                        <a:rPr lang="en-AU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Molecular tags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AU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Yes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AU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No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36633075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rtl="0" fontAlgn="ctr"/>
                      <a:r>
                        <a:rPr lang="en-AU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Limit of detection (LOD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AU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~0.1%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AU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%*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02165264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rtl="0" fontAlgn="ctr"/>
                      <a:r>
                        <a:rPr lang="en-AU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Sensitivity 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AU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&gt;90%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AU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90%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6622955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rtl="0" fontAlgn="ctr"/>
                      <a:r>
                        <a:rPr lang="en-AU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Specificity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AU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&gt;99%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AU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&gt;95%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00901407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rtl="0" fontAlgn="ctr"/>
                      <a:r>
                        <a:rPr lang="en-AU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Number of genes covered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AU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5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AU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612639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rtl="0" fontAlgn="ctr"/>
                      <a:r>
                        <a:rPr lang="en-AU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FFPE and cfDNA compatibl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AU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Yes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AU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Yes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4840545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rtl="0" fontAlgn="ctr"/>
                      <a:r>
                        <a:rPr lang="en-AU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Hands-on tim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AU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.5 hrs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AU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 hrs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95418864"/>
                  </a:ext>
                </a:extLst>
              </a:tr>
              <a:tr h="388620">
                <a:tc gridSpan="3">
                  <a:txBody>
                    <a:bodyPr/>
                    <a:lstStyle/>
                    <a:p>
                      <a:pPr algn="l" rtl="0" fontAlgn="ctr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*LOD of ~0.2% can be achieved using Erase-</a:t>
                      </a:r>
                      <a:r>
                        <a:rPr lang="en-GB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Seq</a:t>
                      </a:r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 bioinformatics pipelin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7581212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70991790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1652A272-25F5-3898-0B7F-0D932AB2287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93719205"/>
              </p:ext>
            </p:extLst>
          </p:nvPr>
        </p:nvGraphicFramePr>
        <p:xfrm>
          <a:off x="4060810" y="1003167"/>
          <a:ext cx="2926585" cy="5200493"/>
        </p:xfrm>
        <a:graphic>
          <a:graphicData uri="http://schemas.openxmlformats.org/drawingml/2006/table">
            <a:tbl>
              <a:tblPr/>
              <a:tblGrid>
                <a:gridCol w="570222">
                  <a:extLst>
                    <a:ext uri="{9D8B030D-6E8A-4147-A177-3AD203B41FA5}">
                      <a16:colId xmlns:a16="http://schemas.microsoft.com/office/drawing/2014/main" val="3736604811"/>
                    </a:ext>
                  </a:extLst>
                </a:gridCol>
                <a:gridCol w="654080">
                  <a:extLst>
                    <a:ext uri="{9D8B030D-6E8A-4147-A177-3AD203B41FA5}">
                      <a16:colId xmlns:a16="http://schemas.microsoft.com/office/drawing/2014/main" val="3807984900"/>
                    </a:ext>
                  </a:extLst>
                </a:gridCol>
                <a:gridCol w="654080">
                  <a:extLst>
                    <a:ext uri="{9D8B030D-6E8A-4147-A177-3AD203B41FA5}">
                      <a16:colId xmlns:a16="http://schemas.microsoft.com/office/drawing/2014/main" val="2854119046"/>
                    </a:ext>
                  </a:extLst>
                </a:gridCol>
                <a:gridCol w="1048203">
                  <a:extLst>
                    <a:ext uri="{9D8B030D-6E8A-4147-A177-3AD203B41FA5}">
                      <a16:colId xmlns:a16="http://schemas.microsoft.com/office/drawing/2014/main" val="3580878351"/>
                    </a:ext>
                  </a:extLst>
                </a:gridCol>
              </a:tblGrid>
              <a:tr h="107731">
                <a:tc gridSpan="4">
                  <a:txBody>
                    <a:bodyPr/>
                    <a:lstStyle/>
                    <a:p>
                      <a:pPr algn="ctr" fontAlgn="b"/>
                      <a:r>
                        <a:rPr lang="en-GB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able S3: ddPCR values for Figure 2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70619547"/>
                  </a:ext>
                </a:extLst>
              </a:tr>
              <a:tr h="201589"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atient ID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utation</a:t>
                      </a:r>
                    </a:p>
                  </a:txBody>
                  <a:tcPr marL="8368" marR="8368" marT="8368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ime</a:t>
                      </a:r>
                    </a:p>
                  </a:txBody>
                  <a:tcPr marL="8368" marR="8368" marT="8368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tDNA (copies/mL)</a:t>
                      </a:r>
                    </a:p>
                  </a:txBody>
                  <a:tcPr marL="8368" marR="8368" marT="836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87373120"/>
                  </a:ext>
                </a:extLst>
              </a:tr>
              <a:tr h="201589"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C3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P53 I195T</a:t>
                      </a:r>
                    </a:p>
                  </a:txBody>
                  <a:tcPr marL="8368" marR="8368" marT="8368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8368" marR="8368" marT="8368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8368" marR="8368" marT="836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36607146"/>
                  </a:ext>
                </a:extLst>
              </a:tr>
              <a:tr h="201589"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C3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P53 I195T</a:t>
                      </a:r>
                    </a:p>
                  </a:txBody>
                  <a:tcPr marL="8368" marR="8368" marT="836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8368" marR="8368" marT="836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0</a:t>
                      </a:r>
                    </a:p>
                  </a:txBody>
                  <a:tcPr marL="8368" marR="8368" marT="836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54580256"/>
                  </a:ext>
                </a:extLst>
              </a:tr>
              <a:tr h="201589"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C3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P53 I195T</a:t>
                      </a:r>
                    </a:p>
                  </a:txBody>
                  <a:tcPr marL="8368" marR="8368" marT="836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8368" marR="8368" marT="836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</a:t>
                      </a:r>
                    </a:p>
                  </a:txBody>
                  <a:tcPr marL="8368" marR="8368" marT="836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71631006"/>
                  </a:ext>
                </a:extLst>
              </a:tr>
              <a:tr h="201589"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C3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P53 I195T</a:t>
                      </a:r>
                    </a:p>
                  </a:txBody>
                  <a:tcPr marL="8368" marR="8368" marT="836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8368" marR="8368" marT="836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</a:t>
                      </a:r>
                    </a:p>
                  </a:txBody>
                  <a:tcPr marL="8368" marR="8368" marT="836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69972457"/>
                  </a:ext>
                </a:extLst>
              </a:tr>
              <a:tr h="201589"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C4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P53 R248Q</a:t>
                      </a:r>
                    </a:p>
                  </a:txBody>
                  <a:tcPr marL="8368" marR="8368" marT="836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8368" marR="8368" marT="836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</a:t>
                      </a:r>
                    </a:p>
                  </a:txBody>
                  <a:tcPr marL="8368" marR="8368" marT="836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05534636"/>
                  </a:ext>
                </a:extLst>
              </a:tr>
              <a:tr h="201589"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C4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P53 Y220C</a:t>
                      </a:r>
                    </a:p>
                  </a:txBody>
                  <a:tcPr marL="8368" marR="8368" marT="836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8368" marR="8368" marT="836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</a:t>
                      </a:r>
                    </a:p>
                  </a:txBody>
                  <a:tcPr marL="8368" marR="8368" marT="836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33847181"/>
                  </a:ext>
                </a:extLst>
              </a:tr>
              <a:tr h="201589"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C4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P53 C238Y</a:t>
                      </a:r>
                    </a:p>
                  </a:txBody>
                  <a:tcPr marL="8368" marR="8368" marT="836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8368" marR="8368" marT="836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8368" marR="8368" marT="836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30423507"/>
                  </a:ext>
                </a:extLst>
              </a:tr>
              <a:tr h="201589"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C4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P53 R273L</a:t>
                      </a:r>
                    </a:p>
                  </a:txBody>
                  <a:tcPr marL="8368" marR="8368" marT="836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8368" marR="8368" marT="836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8368" marR="8368" marT="836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15952375"/>
                  </a:ext>
                </a:extLst>
              </a:tr>
              <a:tr h="201589"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C4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P53 R248Q</a:t>
                      </a:r>
                    </a:p>
                  </a:txBody>
                  <a:tcPr marL="8368" marR="8368" marT="836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8368" marR="8368" marT="836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</a:t>
                      </a:r>
                    </a:p>
                  </a:txBody>
                  <a:tcPr marL="8368" marR="8368" marT="836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4680204"/>
                  </a:ext>
                </a:extLst>
              </a:tr>
              <a:tr h="201589"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C4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P53 Y220C</a:t>
                      </a:r>
                    </a:p>
                  </a:txBody>
                  <a:tcPr marL="8368" marR="8368" marT="836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8368" marR="8368" marT="836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</a:t>
                      </a:r>
                    </a:p>
                  </a:txBody>
                  <a:tcPr marL="8368" marR="8368" marT="836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2015045"/>
                  </a:ext>
                </a:extLst>
              </a:tr>
              <a:tr h="201589"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C4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P53 C238Y</a:t>
                      </a:r>
                    </a:p>
                  </a:txBody>
                  <a:tcPr marL="8368" marR="8368" marT="836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8368" marR="8368" marT="836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8368" marR="8368" marT="836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18721433"/>
                  </a:ext>
                </a:extLst>
              </a:tr>
              <a:tr h="201589"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C4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P53 R273L</a:t>
                      </a:r>
                    </a:p>
                  </a:txBody>
                  <a:tcPr marL="8368" marR="8368" marT="836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8368" marR="8368" marT="836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8368" marR="8368" marT="836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89947654"/>
                  </a:ext>
                </a:extLst>
              </a:tr>
              <a:tr h="201589"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C5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P53 I195T</a:t>
                      </a:r>
                    </a:p>
                  </a:txBody>
                  <a:tcPr marL="8368" marR="8368" marT="836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8368" marR="8368" marT="836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2</a:t>
                      </a:r>
                    </a:p>
                  </a:txBody>
                  <a:tcPr marL="8368" marR="8368" marT="836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29146360"/>
                  </a:ext>
                </a:extLst>
              </a:tr>
              <a:tr h="201589"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C5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P53 I195T</a:t>
                      </a:r>
                    </a:p>
                  </a:txBody>
                  <a:tcPr marL="8368" marR="8368" marT="836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8368" marR="8368" marT="836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0</a:t>
                      </a:r>
                    </a:p>
                  </a:txBody>
                  <a:tcPr marL="8368" marR="8368" marT="836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48729336"/>
                  </a:ext>
                </a:extLst>
              </a:tr>
              <a:tr h="201589"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C5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P53 I195T</a:t>
                      </a:r>
                    </a:p>
                  </a:txBody>
                  <a:tcPr marL="8368" marR="8368" marT="836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8368" marR="8368" marT="836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6</a:t>
                      </a:r>
                    </a:p>
                  </a:txBody>
                  <a:tcPr marL="8368" marR="8368" marT="836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75121996"/>
                  </a:ext>
                </a:extLst>
              </a:tr>
              <a:tr h="201589"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C6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P53 G266R</a:t>
                      </a:r>
                    </a:p>
                  </a:txBody>
                  <a:tcPr marL="8368" marR="8368" marT="836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8368" marR="8368" marT="836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6</a:t>
                      </a:r>
                    </a:p>
                  </a:txBody>
                  <a:tcPr marL="8368" marR="8368" marT="836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17075616"/>
                  </a:ext>
                </a:extLst>
              </a:tr>
              <a:tr h="201589"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C6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P53 G266R</a:t>
                      </a:r>
                    </a:p>
                  </a:txBody>
                  <a:tcPr marL="8368" marR="8368" marT="836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8368" marR="8368" marT="836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8368" marR="8368" marT="836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60623671"/>
                  </a:ext>
                </a:extLst>
              </a:tr>
              <a:tr h="201589"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C6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P53 G266R</a:t>
                      </a:r>
                    </a:p>
                  </a:txBody>
                  <a:tcPr marL="8368" marR="8368" marT="836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8368" marR="8368" marT="836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8368" marR="8368" marT="836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35717963"/>
                  </a:ext>
                </a:extLst>
              </a:tr>
              <a:tr h="201589"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C6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P53 G266R</a:t>
                      </a:r>
                    </a:p>
                  </a:txBody>
                  <a:tcPr marL="8368" marR="8368" marT="836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8368" marR="8368" marT="836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8</a:t>
                      </a:r>
                    </a:p>
                  </a:txBody>
                  <a:tcPr marL="8368" marR="8368" marT="836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82649223"/>
                  </a:ext>
                </a:extLst>
              </a:tr>
              <a:tr h="201589"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C6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P53 G266R</a:t>
                      </a:r>
                    </a:p>
                  </a:txBody>
                  <a:tcPr marL="8368" marR="8368" marT="836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</a:t>
                      </a:r>
                    </a:p>
                  </a:txBody>
                  <a:tcPr marL="8368" marR="8368" marT="836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8</a:t>
                      </a:r>
                    </a:p>
                  </a:txBody>
                  <a:tcPr marL="8368" marR="8368" marT="836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79522352"/>
                  </a:ext>
                </a:extLst>
              </a:tr>
              <a:tr h="201589"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C6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P53 G266R</a:t>
                      </a:r>
                    </a:p>
                  </a:txBody>
                  <a:tcPr marL="8368" marR="8368" marT="836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</a:p>
                  </a:txBody>
                  <a:tcPr marL="8368" marR="8368" marT="836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4</a:t>
                      </a:r>
                    </a:p>
                  </a:txBody>
                  <a:tcPr marL="8368" marR="8368" marT="836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26959166"/>
                  </a:ext>
                </a:extLst>
              </a:tr>
              <a:tr h="201589"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C6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P53 G266R</a:t>
                      </a:r>
                    </a:p>
                  </a:txBody>
                  <a:tcPr marL="8368" marR="8368" marT="836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</a:t>
                      </a:r>
                    </a:p>
                  </a:txBody>
                  <a:tcPr marL="8368" marR="8368" marT="836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4</a:t>
                      </a:r>
                    </a:p>
                  </a:txBody>
                  <a:tcPr marL="8368" marR="8368" marT="836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88784992"/>
                  </a:ext>
                </a:extLst>
              </a:tr>
              <a:tr h="201589"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C6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P53 G266R</a:t>
                      </a:r>
                    </a:p>
                  </a:txBody>
                  <a:tcPr marL="8368" marR="8368" marT="836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</a:t>
                      </a:r>
                    </a:p>
                  </a:txBody>
                  <a:tcPr marL="8368" marR="8368" marT="836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4</a:t>
                      </a:r>
                    </a:p>
                  </a:txBody>
                  <a:tcPr marL="8368" marR="8368" marT="836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0000521"/>
                  </a:ext>
                </a:extLst>
              </a:tr>
              <a:tr h="201589"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C6</a:t>
                      </a:r>
                    </a:p>
                  </a:txBody>
                  <a:tcPr marL="8368" marR="8368" marT="836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P53 G266R</a:t>
                      </a:r>
                    </a:p>
                  </a:txBody>
                  <a:tcPr marL="8368" marR="8368" marT="836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</a:t>
                      </a:r>
                    </a:p>
                  </a:txBody>
                  <a:tcPr marL="8368" marR="8368" marT="836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8</a:t>
                      </a:r>
                    </a:p>
                  </a:txBody>
                  <a:tcPr marL="8368" marR="8368" marT="8368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3565028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39808842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82498EA7-3917-4E13-900F-D8FCFFA72BFD}"/>
              </a:ext>
            </a:extLst>
          </p:cNvPr>
          <p:cNvSpPr txBox="1"/>
          <p:nvPr/>
        </p:nvSpPr>
        <p:spPr>
          <a:xfrm>
            <a:off x="1491929" y="310760"/>
            <a:ext cx="9138571" cy="4490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AU" sz="1159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: TP53 SNVs in Tumour and </a:t>
            </a:r>
            <a:r>
              <a:rPr lang="en-AU" sz="1159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fDNA</a:t>
            </a:r>
            <a:r>
              <a:rPr lang="en-AU" sz="1159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AU" sz="1159" dirty="0">
                <a:latin typeface="Times New Roman" panose="02020603050405020304" pitchFamily="18" charset="0"/>
                <a:cs typeface="Times New Roman" panose="02020603050405020304" pitchFamily="18" charset="0"/>
              </a:rPr>
              <a:t>Venn diagram representing: </a:t>
            </a:r>
            <a:r>
              <a:rPr lang="en-AU" sz="1159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) </a:t>
            </a:r>
            <a:r>
              <a:rPr lang="en-AU" sz="1159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total number of SNVs in TP53 that were detectable in tumour and </a:t>
            </a:r>
            <a:r>
              <a:rPr lang="en-AU" sz="1159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tDNA</a:t>
            </a:r>
            <a:r>
              <a:rPr lang="en-AU" sz="1159" dirty="0">
                <a:latin typeface="Times New Roman" panose="02020603050405020304" pitchFamily="18" charset="0"/>
                <a:cs typeface="Times New Roman" panose="02020603050405020304" pitchFamily="18" charset="0"/>
              </a:rPr>
              <a:t> using the Swift or </a:t>
            </a:r>
            <a:r>
              <a:rPr lang="en-AU" sz="1159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ncomine</a:t>
            </a:r>
            <a:r>
              <a:rPr lang="en-AU" sz="1159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reast V2 NGS panel in 10 HGSOC patients; </a:t>
            </a:r>
            <a:r>
              <a:rPr lang="en-AU" sz="1159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) </a:t>
            </a:r>
            <a:r>
              <a:rPr lang="en-AU" sz="1159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number of patients with identified SNVs in tissue and </a:t>
            </a:r>
            <a:r>
              <a:rPr lang="en-AU" sz="1159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tDNA</a:t>
            </a:r>
            <a:r>
              <a:rPr lang="en-AU" sz="1159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en-AU" sz="1159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1B374F89-E761-4B7F-A6B0-AFB10070F7F7}"/>
              </a:ext>
            </a:extLst>
          </p:cNvPr>
          <p:cNvSpPr txBox="1"/>
          <p:nvPr/>
        </p:nvSpPr>
        <p:spPr>
          <a:xfrm>
            <a:off x="1491929" y="1655014"/>
            <a:ext cx="522554" cy="3217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491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)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BC832DDF-F6CD-4DE9-8366-CAA8B45E76AB}"/>
              </a:ext>
            </a:extLst>
          </p:cNvPr>
          <p:cNvSpPr txBox="1"/>
          <p:nvPr/>
        </p:nvSpPr>
        <p:spPr>
          <a:xfrm>
            <a:off x="6546498" y="1655015"/>
            <a:ext cx="522554" cy="3217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491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)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5DC571FE-3FA7-4A2A-A193-C5606E3FD6D0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4078" r="17083" b="5296"/>
          <a:stretch/>
        </p:blipFill>
        <p:spPr>
          <a:xfrm>
            <a:off x="7069052" y="1655014"/>
            <a:ext cx="4394980" cy="4038420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567C61B7-630B-42F3-8121-A5A8163D88D6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5138" r="17826" b="4660"/>
          <a:stretch/>
        </p:blipFill>
        <p:spPr>
          <a:xfrm>
            <a:off x="2014483" y="1655014"/>
            <a:ext cx="4314909" cy="409880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051556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8D992C4D-0C43-0EBD-CF3B-BC798A3C2788}"/>
              </a:ext>
            </a:extLst>
          </p:cNvPr>
          <p:cNvSpPr txBox="1"/>
          <p:nvPr/>
        </p:nvSpPr>
        <p:spPr>
          <a:xfrm>
            <a:off x="0" y="0"/>
            <a:ext cx="12192000" cy="4490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AU" sz="1159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: IGV view of mutations not detected by ddPCR. </a:t>
            </a:r>
            <a:r>
              <a:rPr lang="en-AU" sz="1159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tegrative Genomics Viewer review of mutations found in plasma via </a:t>
            </a:r>
            <a:r>
              <a:rPr lang="en-AU" sz="1159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ncomine</a:t>
            </a:r>
            <a:r>
              <a:rPr lang="en-AU" sz="1159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not via </a:t>
            </a:r>
            <a:r>
              <a:rPr lang="en-AU" sz="1159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dPCR</a:t>
            </a:r>
            <a:r>
              <a:rPr lang="en-AU" sz="1159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Reads down sampled to 1000, frequency abundance = 0.001.</a:t>
            </a:r>
            <a:endParaRPr lang="en-AU" sz="1159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F550FED1-877F-37B6-9B4F-95932894236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33861" y="523491"/>
            <a:ext cx="868680" cy="5355771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C171D66F-EC66-A5C0-0F95-27A7E1FD97A5}"/>
              </a:ext>
            </a:extLst>
          </p:cNvPr>
          <p:cNvSpPr txBox="1"/>
          <p:nvPr/>
        </p:nvSpPr>
        <p:spPr>
          <a:xfrm>
            <a:off x="3642443" y="5879262"/>
            <a:ext cx="85151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AU" dirty="0">
                <a:latin typeface="Times New Roman" panose="02020603050405020304" pitchFamily="18" charset="0"/>
                <a:cs typeface="Times New Roman" panose="02020603050405020304" pitchFamily="18" charset="0"/>
              </a:rPr>
              <a:t>OC2</a:t>
            </a:r>
          </a:p>
          <a:p>
            <a:r>
              <a:rPr lang="en-AU" dirty="0">
                <a:latin typeface="Times New Roman" panose="02020603050405020304" pitchFamily="18" charset="0"/>
                <a:cs typeface="Times New Roman" panose="02020603050405020304" pitchFamily="18" charset="0"/>
              </a:rPr>
              <a:t>R273H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26C52262-FE25-2C31-804D-98DB9E919C2F}"/>
              </a:ext>
            </a:extLst>
          </p:cNvPr>
          <p:cNvSpPr txBox="1"/>
          <p:nvPr/>
        </p:nvSpPr>
        <p:spPr>
          <a:xfrm>
            <a:off x="4925164" y="5879262"/>
            <a:ext cx="82586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AU" dirty="0">
                <a:latin typeface="Times New Roman" panose="02020603050405020304" pitchFamily="18" charset="0"/>
                <a:cs typeface="Times New Roman" panose="02020603050405020304" pitchFamily="18" charset="0"/>
              </a:rPr>
              <a:t>OC4</a:t>
            </a:r>
          </a:p>
          <a:p>
            <a:r>
              <a:rPr lang="en-AU" dirty="0">
                <a:latin typeface="Times New Roman" panose="02020603050405020304" pitchFamily="18" charset="0"/>
                <a:cs typeface="Times New Roman" panose="02020603050405020304" pitchFamily="18" charset="0"/>
              </a:rPr>
              <a:t>R273L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C4AD35F1-11E0-8F56-924F-EDF3732C5692}"/>
              </a:ext>
            </a:extLst>
          </p:cNvPr>
          <p:cNvSpPr txBox="1"/>
          <p:nvPr/>
        </p:nvSpPr>
        <p:spPr>
          <a:xfrm>
            <a:off x="3848100" y="6488668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AU" dirty="0"/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id="{E2B6193E-65A6-2555-2FF3-6E7B45BD89B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905339" y="523490"/>
            <a:ext cx="865514" cy="5355771"/>
          </a:xfrm>
          <a:prstGeom prst="rect">
            <a:avLst/>
          </a:prstGeom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id="{13DFCBE2-02F9-8E79-A3F9-BAB7F56C8F4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173651" y="523490"/>
            <a:ext cx="813452" cy="5355771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31BD3CFE-F623-B9E4-DEC6-DEA8859631C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329790" y="1954757"/>
            <a:ext cx="628738" cy="152421"/>
          </a:xfrm>
          <a:prstGeom prst="rect">
            <a:avLst/>
          </a:prstGeom>
        </p:spPr>
      </p:pic>
      <p:sp>
        <p:nvSpPr>
          <p:cNvPr id="24" name="TextBox 23">
            <a:extLst>
              <a:ext uri="{FF2B5EF4-FFF2-40B4-BE49-F238E27FC236}">
                <a16:creationId xmlns:a16="http://schemas.microsoft.com/office/drawing/2014/main" id="{BD16589D-6A07-34E8-BE06-BD4A90742A10}"/>
              </a:ext>
            </a:extLst>
          </p:cNvPr>
          <p:cNvSpPr txBox="1"/>
          <p:nvPr/>
        </p:nvSpPr>
        <p:spPr>
          <a:xfrm>
            <a:off x="6171817" y="5879262"/>
            <a:ext cx="82586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AU" dirty="0">
                <a:latin typeface="Times New Roman" panose="02020603050405020304" pitchFamily="18" charset="0"/>
                <a:cs typeface="Times New Roman" panose="02020603050405020304" pitchFamily="18" charset="0"/>
              </a:rPr>
              <a:t>OC7</a:t>
            </a:r>
          </a:p>
          <a:p>
            <a:r>
              <a:rPr lang="en-AU" sz="18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378fs</a:t>
            </a:r>
            <a:endParaRPr lang="en-AU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6" name="Picture 25">
            <a:extLst>
              <a:ext uri="{FF2B5EF4-FFF2-40B4-BE49-F238E27FC236}">
                <a16:creationId xmlns:a16="http://schemas.microsoft.com/office/drawing/2014/main" id="{7E0015C8-AB65-5E80-B688-0B2CB035519D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386644" y="523490"/>
            <a:ext cx="802387" cy="5355771"/>
          </a:xfrm>
          <a:prstGeom prst="rect">
            <a:avLst/>
          </a:prstGeom>
        </p:spPr>
      </p:pic>
      <p:sp>
        <p:nvSpPr>
          <p:cNvPr id="27" name="TextBox 26">
            <a:extLst>
              <a:ext uri="{FF2B5EF4-FFF2-40B4-BE49-F238E27FC236}">
                <a16:creationId xmlns:a16="http://schemas.microsoft.com/office/drawing/2014/main" id="{8507BC61-17B3-0D04-6ABE-F5A86DD7724A}"/>
              </a:ext>
            </a:extLst>
          </p:cNvPr>
          <p:cNvSpPr txBox="1"/>
          <p:nvPr/>
        </p:nvSpPr>
        <p:spPr>
          <a:xfrm>
            <a:off x="7320335" y="5879261"/>
            <a:ext cx="85151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AU" dirty="0">
                <a:latin typeface="Times New Roman" panose="02020603050405020304" pitchFamily="18" charset="0"/>
                <a:cs typeface="Times New Roman" panose="02020603050405020304" pitchFamily="18" charset="0"/>
              </a:rPr>
              <a:t>OC9</a:t>
            </a:r>
          </a:p>
          <a:p>
            <a:r>
              <a:rPr lang="en-AU" sz="18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Y234C</a:t>
            </a:r>
            <a:endParaRPr lang="en-AU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826907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45</TotalTime>
  <Words>1236</Words>
  <Application>Microsoft Office PowerPoint</Application>
  <PresentationFormat>Widescreen</PresentationFormat>
  <Paragraphs>596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aron BEASLEY</dc:creator>
  <cp:lastModifiedBy>Elin GRAY</cp:lastModifiedBy>
  <cp:revision>4</cp:revision>
  <dcterms:created xsi:type="dcterms:W3CDTF">2021-08-23T13:44:54Z</dcterms:created>
  <dcterms:modified xsi:type="dcterms:W3CDTF">2022-12-31T01:19:14Z</dcterms:modified>
</cp:coreProperties>
</file>